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815"/>
    <p:restoredTop sz="94677"/>
  </p:normalViewPr>
  <p:slideViewPr>
    <p:cSldViewPr snapToGrid="0" snapToObjects="1">
      <p:cViewPr varScale="1">
        <p:scale>
          <a:sx n="105" d="100"/>
          <a:sy n="105" d="100"/>
        </p:scale>
        <p:origin x="5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A7F954-DB2D-7741-8DFF-011BC66F42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67D772-698B-574C-A2D1-1AFF908979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81FC33-E728-224B-93B4-EFFB60E26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6B1CAC-C472-DB4E-8251-BEC2A69C0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5411C9-4A91-BE49-A1A9-62D0D833C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193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AE72A0-217C-FB46-B13B-FBEA2C8320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2F2061-1CDD-2B42-882C-A3762A7C82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C5581C-C314-BA44-B794-5FAE0AE6CB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3F7529-26D9-D545-B29C-0B03BF624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01D97-1FAE-CA49-945F-1999BD81A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510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979453-1B1A-1840-AC20-A00DE9D679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A48C74-9529-074B-9A5C-AD09B3C1C3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8A9E4A-A3A2-4B43-832A-95245439C9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D34279-1FA1-F441-AC8F-4B4DFE2F0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5285EF-2315-EB4F-815C-90EC52C3E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701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80A690-D1BB-F346-9B23-C9335D1294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242EFB-6A56-3E4F-93C0-FCA5EFB5FF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7BEAE7-6153-084E-B26A-50A3B5E7E2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E506CD-FEAF-D54F-B510-A171E0145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9FC7AD-5705-6149-942A-428B5B92D5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788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AF22D3-505A-5746-A3A2-9E508C69B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D5259C-9FDD-6049-A1F8-20BF10EDE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F18E38-4D96-0543-9032-56CEF0F3E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626E9F-445A-DB43-9446-6467DF752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27C346-B9B7-6242-8F02-B5099D140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560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DE6F66-6B1C-C144-B002-AB0A721B07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2F93B9-7048-9846-B5A0-3B73F6C23C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B6F584-2ADD-3A45-A049-1E3E174B11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376E7A-6976-684D-942F-1C1C352FCA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72BE53-D044-4E43-AA9C-421D39D7F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7663ED-60BB-1947-B882-89472F598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12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094C67-DEF0-CB43-90EA-D67109F2EC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D6481F-6BCD-EB43-B56A-F93400CDCE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06572E-7E0F-0044-BB28-01CD13EAEA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8A20834-AFF1-CB44-902E-CBC267A6CF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715C72-3716-CC43-BBC7-82331C5819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CC9C87-BF88-BD4C-B66C-DAF9FAF3D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6259AD-BF79-9C40-B6E3-BB3EEBBFC7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661033-61D7-5848-9B60-9FBB56A82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363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4D30F9-15D0-2D4A-89C2-9F8A407D4F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7CD5FB-E89B-DD48-9353-E732BD910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14D83A-F2C3-6F46-8031-9909B9763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BD4BB6E-A97A-9847-A773-3AAEEAC16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403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8B6EDE-7D0C-5342-B22B-5DAE357CA5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5825DC5-CFE9-154E-97FF-91FA89891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43B874-731A-8B46-817F-D7F367BA3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473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3FC534-3E6E-334D-8B30-60FC113DDF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94A767-DD0E-D046-B5CB-17AE78C638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7EB3B8-BC12-5742-BF58-859675AC73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D78418-A791-424C-82E0-E086DA617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3AE847-7BBF-914D-9428-4071D57F1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D4D74F-C32D-6642-BAF4-F50F66CDA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764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F6B7E6-EF25-6C4E-8CD7-D22B61DC0E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0B5E590-DAD5-D042-A860-EAC63C3398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F0BFB6-D4C4-F445-8BE9-E1BE2F8717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FB00C6-5BBD-0948-8523-516DE6551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CBDD1B-7C2C-CF4E-816A-7D426FDCB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61A018-D866-5043-B079-958A7829D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494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D4A55DF-6445-244C-80F4-964094E293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7C0562-CBFA-3842-9DEA-77ABF29F21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B541C2-DCD9-9740-AF01-582439786E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DDE2FF-720E-964F-A6DE-DC5B0FE54F0C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097E91-6DBC-5541-AB50-1532546642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DAE675-CA93-A44F-98D8-42DEC1A0E5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0150EF-5020-774B-9E2D-6903930C59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878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CE53035-BF2F-9E43-8781-064E212D96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41007" y="86498"/>
            <a:ext cx="4680971" cy="485463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23245A7-0403-8848-AF3D-92C334A0E9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41007" y="4978475"/>
            <a:ext cx="4680971" cy="170001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8A87430-277A-784D-A3DF-CB065B855FE8}"/>
              </a:ext>
            </a:extLst>
          </p:cNvPr>
          <p:cNvSpPr txBox="1"/>
          <p:nvPr/>
        </p:nvSpPr>
        <p:spPr>
          <a:xfrm>
            <a:off x="7441007" y="179510"/>
            <a:ext cx="10278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GRP78 </a:t>
            </a:r>
          </a:p>
          <a:p>
            <a:r>
              <a:rPr lang="en-US" b="1" dirty="0"/>
              <a:t>lot#110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EAB7E8A-5921-1A4E-A8C2-D54198FC0704}"/>
              </a:ext>
            </a:extLst>
          </p:cNvPr>
          <p:cNvSpPr txBox="1"/>
          <p:nvPr/>
        </p:nvSpPr>
        <p:spPr>
          <a:xfrm>
            <a:off x="0" y="-37344"/>
            <a:ext cx="7424789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 </a:t>
            </a:r>
            <a:endParaRPr lang="en-US" dirty="0"/>
          </a:p>
          <a:p>
            <a:r>
              <a:rPr lang="en-US" b="1" dirty="0"/>
              <a:t>Figure S4A: </a:t>
            </a:r>
          </a:p>
          <a:p>
            <a:r>
              <a:rPr lang="en-US" dirty="0"/>
              <a:t>The fractions of GRP78 peptides with glycosylation  modifications (as inferred</a:t>
            </a:r>
          </a:p>
          <a:p>
            <a:r>
              <a:rPr lang="en-US" dirty="0"/>
              <a:t> from the changes in deamidation levels) from various rGRP78 preparation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33933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98FDBE4-F4BC-C945-9B05-F9493BB6B6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70066" y="0"/>
            <a:ext cx="5821934" cy="511753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DE42202-8858-DF43-96DE-AD56F46190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56211" y="5145241"/>
            <a:ext cx="5855236" cy="124980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3E9703D-C549-6E44-A678-4FA1C3A6E462}"/>
              </a:ext>
            </a:extLst>
          </p:cNvPr>
          <p:cNvSpPr txBox="1"/>
          <p:nvPr/>
        </p:nvSpPr>
        <p:spPr>
          <a:xfrm>
            <a:off x="6409575" y="1292"/>
            <a:ext cx="139172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GRP78 </a:t>
            </a:r>
          </a:p>
          <a:p>
            <a:r>
              <a:rPr lang="en-US" b="1" dirty="0"/>
              <a:t>lot#120914B</a:t>
            </a:r>
          </a:p>
          <a:p>
            <a:endParaRPr lang="en-US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470B8EE-D39F-554C-B8A0-BBC2F885EFE2}"/>
              </a:ext>
            </a:extLst>
          </p:cNvPr>
          <p:cNvSpPr txBox="1"/>
          <p:nvPr/>
        </p:nvSpPr>
        <p:spPr>
          <a:xfrm>
            <a:off x="0" y="-275707"/>
            <a:ext cx="6409575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 </a:t>
            </a:r>
            <a:endParaRPr lang="en-US" dirty="0"/>
          </a:p>
          <a:p>
            <a:r>
              <a:rPr lang="en-US" b="1" dirty="0"/>
              <a:t>Figure S4B: </a:t>
            </a:r>
          </a:p>
          <a:p>
            <a:r>
              <a:rPr lang="en-US" dirty="0"/>
              <a:t>The fractions of GRP78 peptides with glycosylation modifications</a:t>
            </a:r>
          </a:p>
          <a:p>
            <a:r>
              <a:rPr lang="en-US" dirty="0"/>
              <a:t> (as inferred from the changes in deamidation levels) from various </a:t>
            </a:r>
          </a:p>
          <a:p>
            <a:r>
              <a:rPr lang="en-US" dirty="0"/>
              <a:t>rGRP78 preparation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13594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310A733-C42C-DE44-81A0-126BE8D370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38700" y="1083618"/>
            <a:ext cx="7353300" cy="56261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0DFBADB-58D7-664D-81D2-647192F9DBBB}"/>
              </a:ext>
            </a:extLst>
          </p:cNvPr>
          <p:cNvSpPr txBox="1"/>
          <p:nvPr/>
        </p:nvSpPr>
        <p:spPr>
          <a:xfrm>
            <a:off x="0" y="-275707"/>
            <a:ext cx="6409575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 </a:t>
            </a:r>
            <a:endParaRPr lang="en-US" dirty="0"/>
          </a:p>
          <a:p>
            <a:r>
              <a:rPr lang="en-US" b="1" dirty="0"/>
              <a:t>Figure S4C: </a:t>
            </a:r>
          </a:p>
          <a:p>
            <a:r>
              <a:rPr lang="en-US" dirty="0"/>
              <a:t>The fractions of GRP78 peptides with glycosylation modifications</a:t>
            </a:r>
          </a:p>
          <a:p>
            <a:r>
              <a:rPr lang="en-US" dirty="0"/>
              <a:t> (as inferred from the changes in deamidation levels) from various </a:t>
            </a:r>
          </a:p>
          <a:p>
            <a:r>
              <a:rPr lang="en-US" dirty="0"/>
              <a:t>rGRP78 preparations.</a:t>
            </a:r>
          </a:p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B7D615-FEA6-D342-9A46-58E6D1D3E1A1}"/>
              </a:ext>
            </a:extLst>
          </p:cNvPr>
          <p:cNvSpPr txBox="1"/>
          <p:nvPr/>
        </p:nvSpPr>
        <p:spPr>
          <a:xfrm>
            <a:off x="4838700" y="1092198"/>
            <a:ext cx="126188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GRP78 </a:t>
            </a:r>
          </a:p>
          <a:p>
            <a:r>
              <a:rPr lang="en-US" b="1" dirty="0"/>
              <a:t>lot#130312</a:t>
            </a:r>
          </a:p>
          <a:p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2296136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82241B1-7133-B84D-9D66-B4ECB51BBE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70551" y="86498"/>
            <a:ext cx="5521449" cy="532709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CD3852C-0334-4D42-B52F-7CA8978389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70551" y="5453444"/>
            <a:ext cx="5521449" cy="79259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51B195D-2979-DF4E-9CAD-C93FCA0179F9}"/>
              </a:ext>
            </a:extLst>
          </p:cNvPr>
          <p:cNvSpPr txBox="1"/>
          <p:nvPr/>
        </p:nvSpPr>
        <p:spPr>
          <a:xfrm>
            <a:off x="6758954" y="150296"/>
            <a:ext cx="126188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GRP78 </a:t>
            </a:r>
          </a:p>
          <a:p>
            <a:r>
              <a:rPr lang="en-US" b="1" dirty="0"/>
              <a:t>lot#140923</a:t>
            </a:r>
          </a:p>
          <a:p>
            <a:endParaRPr lang="en-US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7B0CF64-DCA6-F44C-B952-CF1B8745D3F7}"/>
              </a:ext>
            </a:extLst>
          </p:cNvPr>
          <p:cNvSpPr txBox="1"/>
          <p:nvPr/>
        </p:nvSpPr>
        <p:spPr>
          <a:xfrm>
            <a:off x="0" y="-275707"/>
            <a:ext cx="6409575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 </a:t>
            </a:r>
            <a:endParaRPr lang="en-US" dirty="0"/>
          </a:p>
          <a:p>
            <a:r>
              <a:rPr lang="en-US" b="1" dirty="0"/>
              <a:t>Figure S4D:</a:t>
            </a:r>
          </a:p>
          <a:p>
            <a:r>
              <a:rPr lang="en-US" dirty="0"/>
              <a:t>The fractions of GRP78 peptides with glycosylation modifications</a:t>
            </a:r>
          </a:p>
          <a:p>
            <a:r>
              <a:rPr lang="en-US" dirty="0"/>
              <a:t> (as inferred from the changes in deamidation levels) from various </a:t>
            </a:r>
          </a:p>
          <a:p>
            <a:r>
              <a:rPr lang="en-US" dirty="0"/>
              <a:t>rGRP78 preparation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648620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A40B888-4FC2-3745-A774-FBC145C261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92700" y="1160850"/>
            <a:ext cx="7099300" cy="55499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909D2A4-643E-4743-BB42-E2ABD486AD5C}"/>
              </a:ext>
            </a:extLst>
          </p:cNvPr>
          <p:cNvSpPr txBox="1"/>
          <p:nvPr/>
        </p:nvSpPr>
        <p:spPr>
          <a:xfrm>
            <a:off x="87246" y="0"/>
            <a:ext cx="6409575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4E:</a:t>
            </a:r>
          </a:p>
          <a:p>
            <a:r>
              <a:rPr lang="en-US" dirty="0"/>
              <a:t>The fractions of GRP78 peptides with glycosylation modifications</a:t>
            </a:r>
          </a:p>
          <a:p>
            <a:r>
              <a:rPr lang="en-US" dirty="0"/>
              <a:t> (as inferred from the changes in deamidation levels) from various </a:t>
            </a:r>
          </a:p>
          <a:p>
            <a:r>
              <a:rPr lang="en-US" dirty="0"/>
              <a:t>rGRP78 preparations.</a:t>
            </a:r>
          </a:p>
          <a:p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818ECC3-DFD3-D844-BFEA-666E303A920F}"/>
              </a:ext>
            </a:extLst>
          </p:cNvPr>
          <p:cNvSpPr txBox="1"/>
          <p:nvPr/>
        </p:nvSpPr>
        <p:spPr>
          <a:xfrm>
            <a:off x="5092700" y="1262404"/>
            <a:ext cx="10118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n-house</a:t>
            </a:r>
          </a:p>
          <a:p>
            <a:r>
              <a:rPr lang="en-US" b="1" dirty="0"/>
              <a:t>rGRP78</a:t>
            </a:r>
          </a:p>
        </p:txBody>
      </p:sp>
    </p:spTree>
    <p:extLst>
      <p:ext uri="{BB962C8B-B14F-4D97-AF65-F5344CB8AC3E}">
        <p14:creationId xmlns:p14="http://schemas.microsoft.com/office/powerpoint/2010/main" val="39288060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157</Words>
  <Application>Microsoft Macintosh PowerPoint</Application>
  <PresentationFormat>Widescreen</PresentationFormat>
  <Paragraphs>3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an Nguyen, Thi Kim</dc:creator>
  <cp:lastModifiedBy>Tran Nguyen, Thi Kim</cp:lastModifiedBy>
  <cp:revision>6</cp:revision>
  <cp:lastPrinted>2020-10-02T21:51:08Z</cp:lastPrinted>
  <dcterms:created xsi:type="dcterms:W3CDTF">2018-08-22T17:49:32Z</dcterms:created>
  <dcterms:modified xsi:type="dcterms:W3CDTF">2020-10-02T21:51:10Z</dcterms:modified>
</cp:coreProperties>
</file>